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8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65"/>
    <p:restoredTop sz="94649"/>
  </p:normalViewPr>
  <p:slideViewPr>
    <p:cSldViewPr snapToGrid="0" snapToObjects="1">
      <p:cViewPr varScale="1">
        <p:scale>
          <a:sx n="96" d="100"/>
          <a:sy n="96" d="100"/>
        </p:scale>
        <p:origin x="34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0FD10D-0945-FA4F-8E27-F6B1C601AC36}" type="datetimeFigureOut">
              <a:rPr lang="en-US" smtClean="0"/>
              <a:t>7/29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562436-6947-9C4C-9D63-B4CC937D28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33426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338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34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323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99607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591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9813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7755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2038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48000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4386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75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6E4B8B-7505-7746-98A7-0CD65817D26D}" type="datetimeFigureOut">
              <a:rPr lang="en-US" smtClean="0"/>
              <a:t>7/29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7F2423-CAD3-9241-A511-87AA85F881A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124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TextBox 1">
            <a:extLst>
              <a:ext uri="{FF2B5EF4-FFF2-40B4-BE49-F238E27FC236}">
                <a16:creationId xmlns:a16="http://schemas.microsoft.com/office/drawing/2014/main" id="{9784E03D-93ED-534B-B5C6-2AFD9CD55E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52925" y="134938"/>
            <a:ext cx="250581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 dirty="0">
                <a:latin typeface="Arial" panose="020B0604020202020204" pitchFamily="34" charset="0"/>
              </a:rPr>
              <a:t>Supplemental Figure 1</a:t>
            </a:r>
          </a:p>
        </p:txBody>
      </p:sp>
      <p:pic>
        <p:nvPicPr>
          <p:cNvPr id="19458" name="Picture 3" descr="2011-09-06 Primary culture aSMA.jpg">
            <a:extLst>
              <a:ext uri="{FF2B5EF4-FFF2-40B4-BE49-F238E27FC236}">
                <a16:creationId xmlns:a16="http://schemas.microsoft.com/office/drawing/2014/main" id="{74F8D519-8CB3-3E4E-BEB4-A9A8A606FB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089" t="9647" r="3056" b="36336"/>
          <a:stretch>
            <a:fillRect/>
          </a:stretch>
        </p:blipFill>
        <p:spPr bwMode="auto">
          <a:xfrm>
            <a:off x="1177925" y="1219200"/>
            <a:ext cx="1935163" cy="1863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9459" name="Picture 17" descr="2011-09-vimentin in stroma primary cultures .jpg">
            <a:extLst>
              <a:ext uri="{FF2B5EF4-FFF2-40B4-BE49-F238E27FC236}">
                <a16:creationId xmlns:a16="http://schemas.microsoft.com/office/drawing/2014/main" id="{5ADD9E6F-E27C-8049-9900-1956A317E45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70" t="1508" r="-951" b="15121"/>
          <a:stretch>
            <a:fillRect/>
          </a:stretch>
        </p:blipFill>
        <p:spPr bwMode="auto">
          <a:xfrm>
            <a:off x="3767138" y="1238250"/>
            <a:ext cx="2054225" cy="29479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460" name="TextBox 15">
            <a:extLst>
              <a:ext uri="{FF2B5EF4-FFF2-40B4-BE49-F238E27FC236}">
                <a16:creationId xmlns:a16="http://schemas.microsoft.com/office/drawing/2014/main" id="{F02A5E5D-0471-8D4C-8C9F-3B974175DE3B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762000" y="2027238"/>
            <a:ext cx="585788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altLang="en-US" sz="1000">
                <a:latin typeface="Arial" panose="020B0604020202020204" pitchFamily="34" charset="0"/>
                <a:cs typeface="Arial" panose="020B0604020202020204" pitchFamily="34" charset="0"/>
              </a:rPr>
              <a:t>-SM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B7E597E6-CD82-A144-8534-37056B7D94C0}"/>
              </a:ext>
            </a:extLst>
          </p:cNvPr>
          <p:cNvSpPr txBox="1"/>
          <p:nvPr/>
        </p:nvSpPr>
        <p:spPr bwMode="auto">
          <a:xfrm rot="16200000">
            <a:off x="3285332" y="2578893"/>
            <a:ext cx="717550" cy="246063"/>
          </a:xfrm>
          <a:prstGeom prst="rect">
            <a:avLst/>
          </a:prstGeom>
          <a:noFill/>
        </p:spPr>
        <p:txBody>
          <a:bodyPr wrap="none">
            <a:spAutoFit/>
          </a:bodyPr>
          <a:lstStyle/>
          <a:p>
            <a:pPr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err="1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Vimentin</a:t>
            </a:r>
            <a:r>
              <a:rPr lang="en-US" sz="100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endParaRPr lang="en-US" sz="1000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9462" name="TextBox 7">
            <a:extLst>
              <a:ext uri="{FF2B5EF4-FFF2-40B4-BE49-F238E27FC236}">
                <a16:creationId xmlns:a16="http://schemas.microsoft.com/office/drawing/2014/main" id="{CE2A85EE-A513-BD49-A86F-B40B3EA062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30438" y="1019175"/>
            <a:ext cx="82073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000" i="1" baseline="3000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9463" name="TextBox 8">
            <a:extLst>
              <a:ext uri="{FF2B5EF4-FFF2-40B4-BE49-F238E27FC236}">
                <a16:creationId xmlns:a16="http://schemas.microsoft.com/office/drawing/2014/main" id="{D60789BA-5F53-F24F-8DF4-1A4C98FBB8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96975" y="1019175"/>
            <a:ext cx="8636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000" i="1" baseline="3000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9464" name="TextBox 7">
            <a:extLst>
              <a:ext uri="{FF2B5EF4-FFF2-40B4-BE49-F238E27FC236}">
                <a16:creationId xmlns:a16="http://schemas.microsoft.com/office/drawing/2014/main" id="{6BE35CB2-4D5F-B741-8539-ECFBB4EBE5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19663" y="1033463"/>
            <a:ext cx="820737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000" i="1" baseline="3000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9465" name="TextBox 8">
            <a:extLst>
              <a:ext uri="{FF2B5EF4-FFF2-40B4-BE49-F238E27FC236}">
                <a16:creationId xmlns:a16="http://schemas.microsoft.com/office/drawing/2014/main" id="{C027A6C0-C0D5-B64B-9202-6032B15048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17938" y="1033463"/>
            <a:ext cx="8636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000" i="1" baseline="3000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altLang="en-US" sz="1000" i="1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000">
                <a:latin typeface="Arial" panose="020B0604020202020204" pitchFamily="34" charset="0"/>
                <a:cs typeface="Arial" panose="020B0604020202020204" pitchFamily="34" charset="0"/>
              </a:rPr>
              <a:t>MF</a:t>
            </a:r>
          </a:p>
        </p:txBody>
      </p:sp>
      <p:sp>
        <p:nvSpPr>
          <p:cNvPr id="19466" name="TextBox 1">
            <a:extLst>
              <a:ext uri="{FF2B5EF4-FFF2-40B4-BE49-F238E27FC236}">
                <a16:creationId xmlns:a16="http://schemas.microsoft.com/office/drawing/2014/main" id="{31CAE872-320C-EE4D-9D5B-940BAD964E6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738" y="5106988"/>
            <a:ext cx="5948362" cy="6000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RDX1-deficiency in MFs induces characteristics found in cancer-associated fibroblasts.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Fs isolated from female 8-wk-old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rdx1</a:t>
            </a:r>
            <a:r>
              <a:rPr lang="en-US" alt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+/+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mice were analyzed for </a:t>
            </a:r>
            <a:r>
              <a:rPr lang="en-US" altLang="en-US" sz="11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-SMA (red), vimentin (red) and Hoechst nuclear stain (blue) by IF. Scale bar in 1</a:t>
            </a:r>
            <a:r>
              <a:rPr lang="en-US" altLang="en-US" sz="1100" dirty="0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lang="en-US" alt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.</a:t>
            </a: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043307A5-7537-7541-B9A7-324A8FEF032B}"/>
              </a:ext>
            </a:extLst>
          </p:cNvPr>
          <p:cNvGrpSpPr/>
          <p:nvPr/>
        </p:nvGrpSpPr>
        <p:grpSpPr>
          <a:xfrm>
            <a:off x="3824015" y="2112731"/>
            <a:ext cx="131715" cy="2013438"/>
            <a:chOff x="3843555" y="2097099"/>
            <a:chExt cx="131715" cy="2013438"/>
          </a:xfrm>
        </p:grpSpPr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AB225A42-1CA7-6A4E-A2FD-316E80A45C1D}"/>
                </a:ext>
              </a:extLst>
            </p:cNvPr>
            <p:cNvCxnSpPr>
              <a:cxnSpLocks/>
            </p:cNvCxnSpPr>
            <p:nvPr/>
          </p:nvCxnSpPr>
          <p:spPr>
            <a:xfrm>
              <a:off x="3843555" y="2097099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E8FA39B7-56D0-274C-87FC-30E14B6D1663}"/>
                </a:ext>
              </a:extLst>
            </p:cNvPr>
            <p:cNvCxnSpPr>
              <a:cxnSpLocks/>
            </p:cNvCxnSpPr>
            <p:nvPr/>
          </p:nvCxnSpPr>
          <p:spPr>
            <a:xfrm>
              <a:off x="3844702" y="3063276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98554C36-ACFD-E44C-A6ED-3F27FE9236F9}"/>
                </a:ext>
              </a:extLst>
            </p:cNvPr>
            <p:cNvCxnSpPr>
              <a:cxnSpLocks/>
            </p:cNvCxnSpPr>
            <p:nvPr/>
          </p:nvCxnSpPr>
          <p:spPr>
            <a:xfrm>
              <a:off x="3843555" y="4110537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 28">
            <a:extLst>
              <a:ext uri="{FF2B5EF4-FFF2-40B4-BE49-F238E27FC236}">
                <a16:creationId xmlns:a16="http://schemas.microsoft.com/office/drawing/2014/main" id="{E5C94A6B-3F0A-3C4E-94E8-C6E60022DA66}"/>
              </a:ext>
            </a:extLst>
          </p:cNvPr>
          <p:cNvGrpSpPr/>
          <p:nvPr/>
        </p:nvGrpSpPr>
        <p:grpSpPr>
          <a:xfrm>
            <a:off x="4919663" y="2112731"/>
            <a:ext cx="131715" cy="2013438"/>
            <a:chOff x="3843555" y="2097099"/>
            <a:chExt cx="131715" cy="2013438"/>
          </a:xfrm>
        </p:grpSpPr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5828ED32-7C17-F046-B6A5-4E2A2CB428C9}"/>
                </a:ext>
              </a:extLst>
            </p:cNvPr>
            <p:cNvCxnSpPr>
              <a:cxnSpLocks/>
            </p:cNvCxnSpPr>
            <p:nvPr/>
          </p:nvCxnSpPr>
          <p:spPr>
            <a:xfrm>
              <a:off x="3843555" y="2097099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EC493A53-2C57-0545-83E2-E119BC78BF3E}"/>
                </a:ext>
              </a:extLst>
            </p:cNvPr>
            <p:cNvCxnSpPr>
              <a:cxnSpLocks/>
            </p:cNvCxnSpPr>
            <p:nvPr/>
          </p:nvCxnSpPr>
          <p:spPr>
            <a:xfrm>
              <a:off x="3844702" y="3063276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304EAB82-6FD9-1442-98F9-ACA48C856B98}"/>
                </a:ext>
              </a:extLst>
            </p:cNvPr>
            <p:cNvCxnSpPr>
              <a:cxnSpLocks/>
            </p:cNvCxnSpPr>
            <p:nvPr/>
          </p:nvCxnSpPr>
          <p:spPr>
            <a:xfrm>
              <a:off x="3843555" y="4110537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0699AB84-70EA-A944-9F34-2B3C9E24CD8F}"/>
              </a:ext>
            </a:extLst>
          </p:cNvPr>
          <p:cNvGrpSpPr/>
          <p:nvPr/>
        </p:nvGrpSpPr>
        <p:grpSpPr>
          <a:xfrm>
            <a:off x="1234802" y="2040060"/>
            <a:ext cx="131715" cy="966177"/>
            <a:chOff x="3843555" y="2097099"/>
            <a:chExt cx="131715" cy="966177"/>
          </a:xfrm>
        </p:grpSpPr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55A292C2-EB8A-104C-80DC-51A0BF3058BB}"/>
                </a:ext>
              </a:extLst>
            </p:cNvPr>
            <p:cNvCxnSpPr>
              <a:cxnSpLocks/>
            </p:cNvCxnSpPr>
            <p:nvPr/>
          </p:nvCxnSpPr>
          <p:spPr>
            <a:xfrm>
              <a:off x="3843555" y="2097099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430E642D-1D2C-6A4B-B158-D0796CBB18B3}"/>
                </a:ext>
              </a:extLst>
            </p:cNvPr>
            <p:cNvCxnSpPr>
              <a:cxnSpLocks/>
            </p:cNvCxnSpPr>
            <p:nvPr/>
          </p:nvCxnSpPr>
          <p:spPr>
            <a:xfrm>
              <a:off x="3844702" y="3063276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2EC668BF-DC0C-1142-8D29-84C927460DEC}"/>
              </a:ext>
            </a:extLst>
          </p:cNvPr>
          <p:cNvGrpSpPr/>
          <p:nvPr/>
        </p:nvGrpSpPr>
        <p:grpSpPr>
          <a:xfrm>
            <a:off x="2230438" y="2043968"/>
            <a:ext cx="131715" cy="966177"/>
            <a:chOff x="3843555" y="2097099"/>
            <a:chExt cx="131715" cy="966177"/>
          </a:xfrm>
        </p:grpSpPr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C16BBE6B-F65A-0C42-870B-CEE7F97ABB19}"/>
                </a:ext>
              </a:extLst>
            </p:cNvPr>
            <p:cNvCxnSpPr>
              <a:cxnSpLocks/>
            </p:cNvCxnSpPr>
            <p:nvPr/>
          </p:nvCxnSpPr>
          <p:spPr>
            <a:xfrm>
              <a:off x="3843555" y="2097099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34C51D86-2793-C447-8900-EE920D17CDBE}"/>
                </a:ext>
              </a:extLst>
            </p:cNvPr>
            <p:cNvCxnSpPr>
              <a:cxnSpLocks/>
            </p:cNvCxnSpPr>
            <p:nvPr/>
          </p:nvCxnSpPr>
          <p:spPr>
            <a:xfrm>
              <a:off x="3844702" y="3063276"/>
              <a:ext cx="130568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84478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</TotalTime>
  <Words>64</Words>
  <Application>Microsoft Macintosh PowerPoint</Application>
  <PresentationFormat>Letter Paper (8.5x11 in)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umann, Carola</dc:creator>
  <cp:lastModifiedBy>Neumann, Carola</cp:lastModifiedBy>
  <cp:revision>5</cp:revision>
  <dcterms:created xsi:type="dcterms:W3CDTF">2019-02-28T19:43:32Z</dcterms:created>
  <dcterms:modified xsi:type="dcterms:W3CDTF">2019-07-29T17:46:50Z</dcterms:modified>
</cp:coreProperties>
</file>